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19588" cy="4319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D7641D-CD75-4F08-B676-7CDF00845D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38862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7080" y="2497320"/>
            <a:ext cx="38862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50232-91E7-4A06-A94E-75505389CD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0824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7080" y="249732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08240" y="249732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C4AE6-E6D5-4C00-AD11-8649870122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31080" y="100800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45080" y="100800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7080" y="249732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31080" y="249732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45080" y="2497320"/>
            <a:ext cx="12510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8155C-ED40-4B4F-AC37-8B3C13E2F7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7080" y="1008000"/>
            <a:ext cx="3886200" cy="285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24"/>
              </a:spcBef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50D17-89F9-4500-BCEE-1EC2A537D7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388620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68D4F-BC43-4C1F-BD0A-1D4ABE1AE2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89612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08240" y="1008000"/>
            <a:ext cx="189612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29EEC-5132-4C77-89E0-333ABDC355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A62C8-CAF5-44E2-B45A-595A3BB96B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7080" y="173160"/>
            <a:ext cx="3886200" cy="3342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24"/>
              </a:spcBef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B6200-361D-47BB-B1F4-E91330B430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08240" y="1008000"/>
            <a:ext cx="189612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7080" y="249732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EF137-0003-4884-9F66-7CAB71A46A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89612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0824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08240" y="249732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C6FEF-590F-4117-A689-DD90EC4B3E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708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08240" y="1008000"/>
            <a:ext cx="189612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7080" y="2497320"/>
            <a:ext cx="3886200" cy="1359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/>
          </a:bodyPr>
          <a:p>
            <a:pPr indent="0">
              <a:spcBef>
                <a:spcPts val="524"/>
              </a:spcBef>
              <a:buNone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D8517-028B-4899-91E8-FB144FEB46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7080" y="173160"/>
            <a:ext cx="3886200" cy="72072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ctr">
            <a:noAutofit/>
          </a:bodyPr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7080" y="1008000"/>
            <a:ext cx="3886200" cy="285120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rmAutofit fontScale="93000"/>
          </a:bodyPr>
          <a:p>
            <a:pPr marL="191520" indent="-1915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1" marL="417600" indent="-16236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2" marL="640800" indent="-128520"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3" marL="896040" indent="-127080">
              <a:spcBef>
                <a:spcPts val="524"/>
              </a:spcBef>
              <a:buClr>
                <a:srgbClr val="000000"/>
              </a:buClr>
              <a:buFont typeface="Arial"/>
              <a:buChar char="–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4" marL="1151640" indent="-12708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5" marL="1151640" indent="-12708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  <a:p>
            <a:pPr lvl="6" marL="1151640" indent="-127080">
              <a:spcBef>
                <a:spcPts val="524"/>
              </a:spcBef>
              <a:buClr>
                <a:srgbClr val="000000"/>
              </a:buClr>
              <a:buFont typeface="Arial"/>
              <a:buChar char="»"/>
              <a:tabLst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7080" y="3935160"/>
            <a:ext cx="1004760" cy="29988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Autofit/>
          </a:bodyPr>
          <a:lstStyle>
            <a:lvl1pPr indent="0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74920" y="3935160"/>
            <a:ext cx="1371600" cy="29988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Autofit/>
          </a:bodyPr>
          <a:lstStyle>
            <a:lvl1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98520" y="3935160"/>
            <a:ext cx="1004760" cy="299880"/>
          </a:xfrm>
          <a:prstGeom prst="rect">
            <a:avLst/>
          </a:prstGeom>
          <a:noFill/>
          <a:ln w="0">
            <a:noFill/>
          </a:ln>
        </p:spPr>
        <p:txBody>
          <a:bodyPr lIns="55080" rIns="55080" tIns="27720" bIns="27720" anchor="t">
            <a:noAutofit/>
          </a:bodyPr>
          <a:lstStyle>
            <a:lvl1pPr indent="0" algn="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fld id="{54EB921E-16F7-4F92-95BE-90D7BB0C6429}" type="slidenum">
              <a:rPr b="0" lang="en-US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5520" y="214200"/>
            <a:ext cx="3694320" cy="3938040"/>
            <a:chOff x="245520" y="214200"/>
            <a:chExt cx="3694320" cy="3938040"/>
          </a:xfrm>
        </p:grpSpPr>
        <p:sp>
          <p:nvSpPr>
            <p:cNvPr id="42" name=""/>
            <p:cNvSpPr/>
            <p:nvPr/>
          </p:nvSpPr>
          <p:spPr>
            <a:xfrm>
              <a:off x="480600" y="214200"/>
              <a:ext cx="872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M   Cg  Sc   P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93400" y="1909080"/>
              <a:ext cx="325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IMGP1433" descr=""/>
            <p:cNvPicPr/>
            <p:nvPr/>
          </p:nvPicPr>
          <p:blipFill>
            <a:blip r:embed="rId1"/>
            <a:srcRect l="0" t="0" r="61302" b="0"/>
            <a:stretch/>
          </p:blipFill>
          <p:spPr>
            <a:xfrm>
              <a:off x="523800" y="393840"/>
              <a:ext cx="398520" cy="152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"/>
            <p:cNvSpPr/>
            <p:nvPr/>
          </p:nvSpPr>
          <p:spPr>
            <a:xfrm>
              <a:off x="460440" y="128124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55760" y="1046160"/>
              <a:ext cx="7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61880" y="1762200"/>
              <a:ext cx="7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5520" y="9367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6960" y="11700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45520" y="16444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55760" y="1046160"/>
              <a:ext cx="7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55760" y="901800"/>
              <a:ext cx="7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45520" y="7920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55760" y="901800"/>
              <a:ext cx="7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45520" y="7920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IMGP1433" descr=""/>
            <p:cNvPicPr/>
            <p:nvPr/>
          </p:nvPicPr>
          <p:blipFill>
            <a:blip r:embed="rId2"/>
            <a:srcRect l="57418" t="0" r="0" b="0"/>
            <a:stretch/>
          </p:blipFill>
          <p:spPr>
            <a:xfrm>
              <a:off x="917640" y="393840"/>
              <a:ext cx="438120" cy="1527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" descr=""/>
            <p:cNvPicPr/>
            <p:nvPr/>
          </p:nvPicPr>
          <p:blipFill>
            <a:blip r:embed="rId3"/>
            <a:srcRect l="3142" t="33369" r="14858" b="5240"/>
            <a:stretch/>
          </p:blipFill>
          <p:spPr>
            <a:xfrm>
              <a:off x="1087560" y="2897280"/>
              <a:ext cx="2733480" cy="122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635040" y="2443320"/>
              <a:ext cx="3151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17400"/>
                  <a:tab algn="l" pos="1235160"/>
                  <a:tab algn="l" pos="1852560"/>
                  <a:tab algn="l" pos="2470320"/>
                  <a:tab algn="l" pos="3087720"/>
                  <a:tab algn="l" pos="3705120"/>
                  <a:tab algn="l" pos="4322880"/>
                  <a:tab algn="l" pos="4940280"/>
                  <a:tab algn="l" pos="5557680"/>
                  <a:tab algn="l" pos="6175440"/>
                  <a:tab algn="l" pos="6792840"/>
                  <a:tab algn="l" pos="7410600"/>
                  <a:tab algn="l" pos="8028000"/>
                  <a:tab algn="l" pos="8645400"/>
                  <a:tab algn="l" pos="9263160"/>
                  <a:tab algn="l" pos="9880560"/>
                  <a:tab algn="l" pos="10497960"/>
                </a:tabLst>
              </a:pPr>
              <a:r>
                <a:rPr b="0" lang="de-DE" sz="1100" spc="-1" strike="noStrike">
                  <a:solidFill>
                    <a:srgbClr val="000000"/>
                  </a:solidFill>
                  <a:latin typeface="Arial"/>
                </a:rPr>
                <a:t>Protease       -      Sc    Ca    Ca    Ca    Ca    C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33600" y="2652840"/>
              <a:ext cx="3306240" cy="26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17400"/>
                  <a:tab algn="l" pos="1235160"/>
                  <a:tab algn="l" pos="1852560"/>
                  <a:tab algn="l" pos="2470320"/>
                  <a:tab algn="l" pos="3087720"/>
                  <a:tab algn="l" pos="3705120"/>
                  <a:tab algn="l" pos="4322880"/>
                  <a:tab algn="l" pos="4940280"/>
                  <a:tab algn="l" pos="5557680"/>
                  <a:tab algn="l" pos="6175440"/>
                  <a:tab algn="l" pos="6792840"/>
                  <a:tab algn="l" pos="7410600"/>
                  <a:tab algn="l" pos="8028000"/>
                  <a:tab algn="l" pos="8645400"/>
                  <a:tab algn="l" pos="9263160"/>
                  <a:tab algn="l" pos="9880560"/>
                  <a:tab algn="l" pos="1049796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Inhibitor         -        -       -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PMSF   EDTA   ZnCl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 Pepsta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45240" y="3890880"/>
              <a:ext cx="281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17400"/>
                  <a:tab algn="l" pos="1235160"/>
                  <a:tab algn="l" pos="1852560"/>
                  <a:tab algn="l" pos="2470320"/>
                  <a:tab algn="l" pos="3087720"/>
                  <a:tab algn="l" pos="3705120"/>
                  <a:tab algn="l" pos="4322880"/>
                  <a:tab algn="l" pos="4940280"/>
                  <a:tab algn="l" pos="5557680"/>
                  <a:tab algn="l" pos="6175440"/>
                  <a:tab algn="l" pos="6792840"/>
                  <a:tab algn="l" pos="7410600"/>
                  <a:tab algn="l" pos="8028000"/>
                  <a:tab algn="l" pos="8645400"/>
                  <a:tab algn="l" pos="9263160"/>
                  <a:tab algn="l" pos="9880560"/>
                  <a:tab algn="l" pos="1049796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362320" y="1103400"/>
              <a:ext cx="591840" cy="321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CaKex2-Act#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"/>
            <p:cNvGrpSpPr/>
            <p:nvPr/>
          </p:nvGrpSpPr>
          <p:grpSpPr>
            <a:xfrm>
              <a:off x="1741680" y="265320"/>
              <a:ext cx="2187720" cy="1831680"/>
              <a:chOff x="1741680" y="265320"/>
              <a:chExt cx="2187720" cy="1831680"/>
            </a:xfrm>
          </p:grpSpPr>
          <p:sp>
            <p:nvSpPr>
              <p:cNvPr id="63" name=""/>
              <p:cNvSpPr/>
              <p:nvPr/>
            </p:nvSpPr>
            <p:spPr>
              <a:xfrm>
                <a:off x="1741680" y="265320"/>
                <a:ext cx="2187720" cy="1831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048040" y="335160"/>
                <a:ext cx="1800" cy="15825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024280" y="1917720"/>
                <a:ext cx="2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024280" y="1465200"/>
                <a:ext cx="2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024280" y="1011240"/>
                <a:ext cx="2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024280" y="558720"/>
                <a:ext cx="237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048040" y="1695600"/>
                <a:ext cx="18288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2048040" y="1695600"/>
                <a:ext cx="1800" cy="2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V="1">
                <a:off x="2619720" y="1695600"/>
                <a:ext cx="1440" cy="2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3192840" y="1695600"/>
                <a:ext cx="1440" cy="2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V="1">
                <a:off x="3764160" y="1695600"/>
                <a:ext cx="1440" cy="25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V="1">
                <a:off x="2159280" y="1630080"/>
                <a:ext cx="1440" cy="334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141640" y="163044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V="1">
                <a:off x="2278440" y="1630440"/>
                <a:ext cx="1440" cy="39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260800" y="163044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V="1">
                <a:off x="2508480" y="16635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490840" y="166392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V="1">
                <a:off x="2732400" y="1617480"/>
                <a:ext cx="1440" cy="83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714760" y="161784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2962440" y="1636560"/>
                <a:ext cx="1800" cy="58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945160" y="1636920"/>
                <a:ext cx="4104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3876840" y="1553760"/>
                <a:ext cx="1800" cy="1350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3859560" y="1554120"/>
                <a:ext cx="4104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159280" y="1663920"/>
                <a:ext cx="1440" cy="25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141640" y="168912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278440" y="1670040"/>
                <a:ext cx="1440" cy="38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260800" y="170820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508480" y="1676520"/>
                <a:ext cx="1440" cy="19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490840" y="169560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732400" y="1701720"/>
                <a:ext cx="1440" cy="763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714760" y="177804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962440" y="1695600"/>
                <a:ext cx="1800" cy="572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945160" y="1752840"/>
                <a:ext cx="4104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876840" y="1689120"/>
                <a:ext cx="1800" cy="127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859560" y="1816200"/>
                <a:ext cx="4104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2159280" y="1089000"/>
                <a:ext cx="1440" cy="44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141640" y="108900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2278440" y="1108080"/>
                <a:ext cx="1440" cy="38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260800" y="110808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508480" y="954000"/>
                <a:ext cx="1440" cy="12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490840" y="95400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2732400" y="827280"/>
                <a:ext cx="1440" cy="31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714760" y="82728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2962440" y="744120"/>
                <a:ext cx="1800" cy="50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945160" y="744480"/>
                <a:ext cx="4104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3876840" y="451080"/>
                <a:ext cx="1800" cy="25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859560" y="451080"/>
                <a:ext cx="4104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159280" y="1133640"/>
                <a:ext cx="1440" cy="44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141640" y="117792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278440" y="1146240"/>
                <a:ext cx="1440" cy="44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260800" y="1190520"/>
                <a:ext cx="4140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508480" y="966960"/>
                <a:ext cx="1440" cy="12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490840" y="97956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732400" y="858960"/>
                <a:ext cx="1440" cy="31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714760" y="890640"/>
                <a:ext cx="4140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962440" y="795240"/>
                <a:ext cx="1800" cy="572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945160" y="852480"/>
                <a:ext cx="41040" cy="18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876840" y="476280"/>
                <a:ext cx="1800" cy="255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859560" y="501840"/>
                <a:ext cx="4104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141640" y="1643040"/>
                <a:ext cx="36720" cy="39960"/>
              </a:xfrm>
              <a:custGeom>
                <a:avLst/>
                <a:gdLst/>
                <a:ahLst/>
                <a:rect l="l" t="t" r="r" b="b"/>
                <a:pathLst>
                  <a:path w="23" h="25">
                    <a:moveTo>
                      <a:pt x="11" y="0"/>
                    </a:moveTo>
                    <a:lnTo>
                      <a:pt x="23" y="13"/>
                    </a:lnTo>
                    <a:lnTo>
                      <a:pt x="11" y="25"/>
                    </a:lnTo>
                    <a:lnTo>
                      <a:pt x="0" y="13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260800" y="1650960"/>
                <a:ext cx="34920" cy="38160"/>
              </a:xfrm>
              <a:custGeom>
                <a:avLst/>
                <a:gdLst/>
                <a:ahLst/>
                <a:rect l="l" t="t" r="r" b="b"/>
                <a:pathLst>
                  <a:path w="22" h="24">
                    <a:moveTo>
                      <a:pt x="11" y="0"/>
                    </a:moveTo>
                    <a:lnTo>
                      <a:pt x="22" y="12"/>
                    </a:lnTo>
                    <a:lnTo>
                      <a:pt x="11" y="24"/>
                    </a:lnTo>
                    <a:lnTo>
                      <a:pt x="0" y="12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490840" y="1657440"/>
                <a:ext cx="35280" cy="38160"/>
              </a:xfrm>
              <a:custGeom>
                <a:avLst/>
                <a:gdLst/>
                <a:ahLst/>
                <a:rect l="l" t="t" r="r" b="b"/>
                <a:pathLst>
                  <a:path w="22" h="24">
                    <a:moveTo>
                      <a:pt x="11" y="0"/>
                    </a:moveTo>
                    <a:lnTo>
                      <a:pt x="22" y="12"/>
                    </a:lnTo>
                    <a:lnTo>
                      <a:pt x="11" y="24"/>
                    </a:lnTo>
                    <a:lnTo>
                      <a:pt x="0" y="12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714760" y="1683000"/>
                <a:ext cx="34920" cy="37800"/>
              </a:xfrm>
              <a:custGeom>
                <a:avLst/>
                <a:gdLst/>
                <a:ahLst/>
                <a:rect l="l" t="t" r="r" b="b"/>
                <a:pathLst>
                  <a:path w="22" h="24">
                    <a:moveTo>
                      <a:pt x="11" y="0"/>
                    </a:moveTo>
                    <a:lnTo>
                      <a:pt x="22" y="12"/>
                    </a:lnTo>
                    <a:lnTo>
                      <a:pt x="11" y="24"/>
                    </a:lnTo>
                    <a:lnTo>
                      <a:pt x="0" y="12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945160" y="1676520"/>
                <a:ext cx="34920" cy="38160"/>
              </a:xfrm>
              <a:custGeom>
                <a:avLst/>
                <a:gdLst/>
                <a:ahLst/>
                <a:rect l="l" t="t" r="r" b="b"/>
                <a:pathLst>
                  <a:path w="22" h="24">
                    <a:moveTo>
                      <a:pt x="11" y="0"/>
                    </a:moveTo>
                    <a:lnTo>
                      <a:pt x="22" y="12"/>
                    </a:lnTo>
                    <a:lnTo>
                      <a:pt x="11" y="24"/>
                    </a:lnTo>
                    <a:lnTo>
                      <a:pt x="0" y="12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859560" y="1670040"/>
                <a:ext cx="34920" cy="38160"/>
              </a:xfrm>
              <a:custGeom>
                <a:avLst/>
                <a:gdLst/>
                <a:ahLst/>
                <a:rect l="l" t="t" r="r" b="b"/>
                <a:pathLst>
                  <a:path w="22" h="24">
                    <a:moveTo>
                      <a:pt x="11" y="0"/>
                    </a:moveTo>
                    <a:lnTo>
                      <a:pt x="22" y="12"/>
                    </a:lnTo>
                    <a:lnTo>
                      <a:pt x="11" y="24"/>
                    </a:lnTo>
                    <a:lnTo>
                      <a:pt x="0" y="12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80"/>
              </a:solidFill>
              <a:ln w="648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141640" y="1114560"/>
                <a:ext cx="3024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260800" y="1127160"/>
                <a:ext cx="2844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490840" y="947880"/>
                <a:ext cx="2880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714760" y="839880"/>
                <a:ext cx="2880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945160" y="776520"/>
                <a:ext cx="2844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859560" y="457200"/>
                <a:ext cx="28440" cy="31680"/>
              </a:xfrm>
              <a:prstGeom prst="rect">
                <a:avLst/>
              </a:prstGeom>
              <a:solidFill>
                <a:srgbClr val="ff00ff"/>
              </a:solidFill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159280" y="476280"/>
                <a:ext cx="1717560" cy="682560"/>
              </a:xfrm>
              <a:custGeom>
                <a:avLst/>
                <a:gdLst/>
                <a:ahLst/>
                <a:rect l="l" t="t" r="r" b="b"/>
                <a:pathLst>
                  <a:path w="291" h="107">
                    <a:moveTo>
                      <a:pt x="0" y="107"/>
                    </a:moveTo>
                    <a:lnTo>
                      <a:pt x="4" y="105"/>
                    </a:lnTo>
                    <a:lnTo>
                      <a:pt x="8" y="103"/>
                    </a:lnTo>
                    <a:lnTo>
                      <a:pt x="12" y="101"/>
                    </a:lnTo>
                    <a:lnTo>
                      <a:pt x="16" y="99"/>
                    </a:lnTo>
                    <a:lnTo>
                      <a:pt x="20" y="98"/>
                    </a:lnTo>
                    <a:lnTo>
                      <a:pt x="24" y="96"/>
                    </a:lnTo>
                    <a:lnTo>
                      <a:pt x="28" y="94"/>
                    </a:lnTo>
                    <a:lnTo>
                      <a:pt x="32" y="92"/>
                    </a:lnTo>
                    <a:lnTo>
                      <a:pt x="36" y="90"/>
                    </a:lnTo>
                    <a:lnTo>
                      <a:pt x="40" y="88"/>
                    </a:lnTo>
                    <a:lnTo>
                      <a:pt x="44" y="86"/>
                    </a:lnTo>
                    <a:lnTo>
                      <a:pt x="48" y="84"/>
                    </a:lnTo>
                    <a:lnTo>
                      <a:pt x="52" y="82"/>
                    </a:lnTo>
                    <a:lnTo>
                      <a:pt x="56" y="81"/>
                    </a:lnTo>
                    <a:lnTo>
                      <a:pt x="60" y="79"/>
                    </a:lnTo>
                    <a:lnTo>
                      <a:pt x="64" y="77"/>
                    </a:lnTo>
                    <a:lnTo>
                      <a:pt x="68" y="75"/>
                    </a:lnTo>
                    <a:lnTo>
                      <a:pt x="72" y="74"/>
                    </a:lnTo>
                    <a:lnTo>
                      <a:pt x="76" y="72"/>
                    </a:lnTo>
                    <a:lnTo>
                      <a:pt x="80" y="70"/>
                    </a:lnTo>
                    <a:lnTo>
                      <a:pt x="84" y="68"/>
                    </a:lnTo>
                    <a:lnTo>
                      <a:pt x="88" y="67"/>
                    </a:lnTo>
                    <a:lnTo>
                      <a:pt x="92" y="65"/>
                    </a:lnTo>
                    <a:lnTo>
                      <a:pt x="96" y="63"/>
                    </a:lnTo>
                    <a:lnTo>
                      <a:pt x="100" y="62"/>
                    </a:lnTo>
                    <a:lnTo>
                      <a:pt x="104" y="60"/>
                    </a:lnTo>
                    <a:lnTo>
                      <a:pt x="108" y="58"/>
                    </a:lnTo>
                    <a:lnTo>
                      <a:pt x="112" y="57"/>
                    </a:lnTo>
                    <a:lnTo>
                      <a:pt x="116" y="55"/>
                    </a:lnTo>
                    <a:lnTo>
                      <a:pt x="120" y="54"/>
                    </a:lnTo>
                    <a:lnTo>
                      <a:pt x="124" y="52"/>
                    </a:lnTo>
                    <a:lnTo>
                      <a:pt x="128" y="51"/>
                    </a:lnTo>
                    <a:lnTo>
                      <a:pt x="132" y="49"/>
                    </a:lnTo>
                    <a:lnTo>
                      <a:pt x="136" y="48"/>
                    </a:lnTo>
                    <a:lnTo>
                      <a:pt x="140" y="46"/>
                    </a:lnTo>
                    <a:lnTo>
                      <a:pt x="144" y="45"/>
                    </a:lnTo>
                    <a:lnTo>
                      <a:pt x="148" y="43"/>
                    </a:lnTo>
                    <a:lnTo>
                      <a:pt x="152" y="42"/>
                    </a:lnTo>
                    <a:lnTo>
                      <a:pt x="156" y="40"/>
                    </a:lnTo>
                    <a:lnTo>
                      <a:pt x="160" y="39"/>
                    </a:lnTo>
                    <a:lnTo>
                      <a:pt x="164" y="37"/>
                    </a:lnTo>
                    <a:lnTo>
                      <a:pt x="168" y="36"/>
                    </a:lnTo>
                    <a:lnTo>
                      <a:pt x="172" y="35"/>
                    </a:lnTo>
                    <a:lnTo>
                      <a:pt x="176" y="33"/>
                    </a:lnTo>
                    <a:lnTo>
                      <a:pt x="180" y="32"/>
                    </a:lnTo>
                    <a:lnTo>
                      <a:pt x="184" y="31"/>
                    </a:lnTo>
                    <a:lnTo>
                      <a:pt x="187" y="29"/>
                    </a:lnTo>
                    <a:lnTo>
                      <a:pt x="191" y="28"/>
                    </a:lnTo>
                    <a:lnTo>
                      <a:pt x="195" y="27"/>
                    </a:lnTo>
                    <a:lnTo>
                      <a:pt x="199" y="25"/>
                    </a:lnTo>
                    <a:lnTo>
                      <a:pt x="203" y="24"/>
                    </a:lnTo>
                    <a:lnTo>
                      <a:pt x="207" y="23"/>
                    </a:lnTo>
                    <a:lnTo>
                      <a:pt x="211" y="22"/>
                    </a:lnTo>
                    <a:lnTo>
                      <a:pt x="215" y="21"/>
                    </a:lnTo>
                    <a:lnTo>
                      <a:pt x="219" y="19"/>
                    </a:lnTo>
                    <a:lnTo>
                      <a:pt x="223" y="18"/>
                    </a:lnTo>
                    <a:lnTo>
                      <a:pt x="227" y="17"/>
                    </a:lnTo>
                    <a:lnTo>
                      <a:pt x="231" y="16"/>
                    </a:lnTo>
                    <a:lnTo>
                      <a:pt x="235" y="15"/>
                    </a:lnTo>
                    <a:lnTo>
                      <a:pt x="239" y="14"/>
                    </a:lnTo>
                    <a:lnTo>
                      <a:pt x="243" y="12"/>
                    </a:lnTo>
                    <a:lnTo>
                      <a:pt x="247" y="11"/>
                    </a:lnTo>
                    <a:lnTo>
                      <a:pt x="251" y="10"/>
                    </a:lnTo>
                    <a:lnTo>
                      <a:pt x="255" y="9"/>
                    </a:lnTo>
                    <a:lnTo>
                      <a:pt x="259" y="8"/>
                    </a:lnTo>
                    <a:lnTo>
                      <a:pt x="263" y="7"/>
                    </a:lnTo>
                    <a:lnTo>
                      <a:pt x="267" y="6"/>
                    </a:lnTo>
                    <a:lnTo>
                      <a:pt x="271" y="5"/>
                    </a:lnTo>
                    <a:lnTo>
                      <a:pt x="275" y="4"/>
                    </a:lnTo>
                    <a:lnTo>
                      <a:pt x="279" y="3"/>
                    </a:lnTo>
                    <a:lnTo>
                      <a:pt x="283" y="2"/>
                    </a:lnTo>
                    <a:lnTo>
                      <a:pt x="287" y="1"/>
                    </a:lnTo>
                    <a:lnTo>
                      <a:pt x="291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159280" y="1657440"/>
                <a:ext cx="1717560" cy="44280"/>
              </a:xfrm>
              <a:custGeom>
                <a:avLst/>
                <a:gdLst/>
                <a:ahLst/>
                <a:rect l="l" t="t" r="r" b="b"/>
                <a:pathLst>
                  <a:path w="291" h="7">
                    <a:moveTo>
                      <a:pt x="0" y="0"/>
                    </a:moveTo>
                    <a:lnTo>
                      <a:pt x="4" y="1"/>
                    </a:lnTo>
                    <a:lnTo>
                      <a:pt x="8" y="1"/>
                    </a:lnTo>
                    <a:lnTo>
                      <a:pt x="12" y="1"/>
                    </a:lnTo>
                    <a:lnTo>
                      <a:pt x="16" y="2"/>
                    </a:lnTo>
                    <a:lnTo>
                      <a:pt x="20" y="2"/>
                    </a:lnTo>
                    <a:lnTo>
                      <a:pt x="24" y="2"/>
                    </a:lnTo>
                    <a:lnTo>
                      <a:pt x="28" y="2"/>
                    </a:lnTo>
                    <a:lnTo>
                      <a:pt x="32" y="3"/>
                    </a:lnTo>
                    <a:lnTo>
                      <a:pt x="36" y="3"/>
                    </a:lnTo>
                    <a:lnTo>
                      <a:pt x="40" y="3"/>
                    </a:lnTo>
                    <a:lnTo>
                      <a:pt x="44" y="3"/>
                    </a:lnTo>
                    <a:lnTo>
                      <a:pt x="48" y="3"/>
                    </a:lnTo>
                    <a:lnTo>
                      <a:pt x="52" y="4"/>
                    </a:lnTo>
                    <a:lnTo>
                      <a:pt x="56" y="4"/>
                    </a:lnTo>
                    <a:lnTo>
                      <a:pt x="60" y="4"/>
                    </a:lnTo>
                    <a:lnTo>
                      <a:pt x="64" y="4"/>
                    </a:lnTo>
                    <a:lnTo>
                      <a:pt x="68" y="4"/>
                    </a:lnTo>
                    <a:lnTo>
                      <a:pt x="72" y="5"/>
                    </a:lnTo>
                    <a:lnTo>
                      <a:pt x="76" y="5"/>
                    </a:lnTo>
                    <a:lnTo>
                      <a:pt x="80" y="5"/>
                    </a:lnTo>
                    <a:lnTo>
                      <a:pt x="84" y="5"/>
                    </a:lnTo>
                    <a:lnTo>
                      <a:pt x="88" y="5"/>
                    </a:lnTo>
                    <a:lnTo>
                      <a:pt x="92" y="5"/>
                    </a:lnTo>
                    <a:lnTo>
                      <a:pt x="96" y="5"/>
                    </a:lnTo>
                    <a:lnTo>
                      <a:pt x="100" y="6"/>
                    </a:lnTo>
                    <a:lnTo>
                      <a:pt x="104" y="6"/>
                    </a:lnTo>
                    <a:lnTo>
                      <a:pt x="108" y="6"/>
                    </a:lnTo>
                    <a:lnTo>
                      <a:pt x="112" y="6"/>
                    </a:lnTo>
                    <a:lnTo>
                      <a:pt x="116" y="6"/>
                    </a:lnTo>
                    <a:lnTo>
                      <a:pt x="120" y="6"/>
                    </a:lnTo>
                    <a:lnTo>
                      <a:pt x="124" y="6"/>
                    </a:lnTo>
                    <a:lnTo>
                      <a:pt x="128" y="6"/>
                    </a:lnTo>
                    <a:lnTo>
                      <a:pt x="132" y="6"/>
                    </a:lnTo>
                    <a:lnTo>
                      <a:pt x="136" y="7"/>
                    </a:lnTo>
                    <a:lnTo>
                      <a:pt x="140" y="7"/>
                    </a:lnTo>
                    <a:lnTo>
                      <a:pt x="144" y="7"/>
                    </a:lnTo>
                    <a:lnTo>
                      <a:pt x="148" y="7"/>
                    </a:lnTo>
                    <a:lnTo>
                      <a:pt x="152" y="7"/>
                    </a:lnTo>
                    <a:lnTo>
                      <a:pt x="156" y="7"/>
                    </a:lnTo>
                    <a:lnTo>
                      <a:pt x="160" y="7"/>
                    </a:lnTo>
                    <a:lnTo>
                      <a:pt x="164" y="7"/>
                    </a:lnTo>
                    <a:lnTo>
                      <a:pt x="168" y="7"/>
                    </a:lnTo>
                    <a:lnTo>
                      <a:pt x="172" y="7"/>
                    </a:lnTo>
                    <a:lnTo>
                      <a:pt x="176" y="7"/>
                    </a:lnTo>
                    <a:lnTo>
                      <a:pt x="180" y="7"/>
                    </a:lnTo>
                    <a:lnTo>
                      <a:pt x="184" y="7"/>
                    </a:lnTo>
                    <a:lnTo>
                      <a:pt x="187" y="7"/>
                    </a:lnTo>
                    <a:lnTo>
                      <a:pt x="191" y="7"/>
                    </a:lnTo>
                    <a:lnTo>
                      <a:pt x="195" y="7"/>
                    </a:lnTo>
                    <a:lnTo>
                      <a:pt x="199" y="7"/>
                    </a:lnTo>
                    <a:lnTo>
                      <a:pt x="203" y="7"/>
                    </a:lnTo>
                    <a:lnTo>
                      <a:pt x="207" y="7"/>
                    </a:lnTo>
                    <a:lnTo>
                      <a:pt x="211" y="7"/>
                    </a:lnTo>
                    <a:lnTo>
                      <a:pt x="215" y="7"/>
                    </a:lnTo>
                    <a:lnTo>
                      <a:pt x="219" y="7"/>
                    </a:lnTo>
                    <a:lnTo>
                      <a:pt x="223" y="7"/>
                    </a:lnTo>
                    <a:lnTo>
                      <a:pt x="227" y="7"/>
                    </a:lnTo>
                    <a:lnTo>
                      <a:pt x="231" y="7"/>
                    </a:lnTo>
                    <a:lnTo>
                      <a:pt x="235" y="6"/>
                    </a:lnTo>
                    <a:lnTo>
                      <a:pt x="239" y="6"/>
                    </a:lnTo>
                    <a:lnTo>
                      <a:pt x="243" y="6"/>
                    </a:lnTo>
                    <a:lnTo>
                      <a:pt x="247" y="6"/>
                    </a:lnTo>
                    <a:lnTo>
                      <a:pt x="251" y="6"/>
                    </a:lnTo>
                    <a:lnTo>
                      <a:pt x="255" y="6"/>
                    </a:lnTo>
                    <a:lnTo>
                      <a:pt x="259" y="6"/>
                    </a:lnTo>
                    <a:lnTo>
                      <a:pt x="263" y="6"/>
                    </a:lnTo>
                    <a:lnTo>
                      <a:pt x="267" y="6"/>
                    </a:lnTo>
                    <a:lnTo>
                      <a:pt x="271" y="6"/>
                    </a:lnTo>
                    <a:lnTo>
                      <a:pt x="275" y="5"/>
                    </a:lnTo>
                    <a:lnTo>
                      <a:pt x="279" y="5"/>
                    </a:lnTo>
                    <a:lnTo>
                      <a:pt x="283" y="5"/>
                    </a:lnTo>
                    <a:lnTo>
                      <a:pt x="287" y="5"/>
                    </a:lnTo>
                    <a:lnTo>
                      <a:pt x="291" y="5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1860120" y="18669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-0,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883520" y="141444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,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883520" y="96048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,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1883520" y="50796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,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030760" y="176544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602080" y="176544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151440" y="17654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722760" y="17654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2354400" y="1203480"/>
                <a:ext cx="98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Ca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449800" y="1203480"/>
                <a:ext cx="174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ex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378520" y="1535040"/>
                <a:ext cx="374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de-DE" sz="600" spc="-1" strike="noStrike">
                    <a:solidFill>
                      <a:srgbClr val="000000"/>
                    </a:solidFill>
                    <a:latin typeface="Arial"/>
                  </a:rPr>
                  <a:t>wt SC53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rot="16200000">
                <a:off x="1471680" y="1103760"/>
                <a:ext cx="7034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</a:rPr>
                  <a:t>absorption 405nm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714400" y="1970280"/>
                <a:ext cx="88020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17400"/>
                    <a:tab algn="l" pos="1235160"/>
                    <a:tab algn="l" pos="1852560"/>
                    <a:tab algn="l" pos="2470320"/>
                    <a:tab algn="l" pos="3087720"/>
                    <a:tab algn="l" pos="3705120"/>
                    <a:tab algn="l" pos="4322880"/>
                    <a:tab algn="l" pos="4940280"/>
                    <a:tab algn="l" pos="5557680"/>
                    <a:tab algn="l" pos="6175440"/>
                    <a:tab algn="l" pos="6792840"/>
                    <a:tab algn="l" pos="7410600"/>
                    <a:tab algn="l" pos="8028000"/>
                    <a:tab algn="l" pos="8645400"/>
                    <a:tab algn="l" pos="9263160"/>
                    <a:tab algn="l" pos="9880560"/>
                    <a:tab algn="l" pos="1049796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</a:rPr>
                  <a:t>post induction time  [h]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"/>
            <p:cNvSpPr/>
            <p:nvPr/>
          </p:nvSpPr>
          <p:spPr>
            <a:xfrm>
              <a:off x="1649880" y="1909800"/>
              <a:ext cx="273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617400"/>
                  <a:tab algn="l" pos="1235160"/>
                  <a:tab algn="l" pos="1852560"/>
                  <a:tab algn="l" pos="2470320"/>
                  <a:tab algn="l" pos="3087720"/>
                  <a:tab algn="l" pos="3705120"/>
                  <a:tab algn="l" pos="4322880"/>
                  <a:tab algn="l" pos="4940280"/>
                  <a:tab algn="l" pos="5557680"/>
                  <a:tab algn="l" pos="6175440"/>
                  <a:tab algn="l" pos="6792840"/>
                  <a:tab algn="l" pos="7410600"/>
                  <a:tab algn="l" pos="8028000"/>
                  <a:tab algn="l" pos="8645400"/>
                  <a:tab algn="l" pos="9263160"/>
                  <a:tab algn="l" pos="9880560"/>
                  <a:tab algn="l" pos="1049796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9T12:23:12Z</dcterms:created>
  <dc:creator>Oliver Bader</dc:creator>
  <dc:description/>
  <dc:language>en-US</dc:language>
  <cp:lastModifiedBy>Oliver Bader</cp:lastModifiedBy>
  <dcterms:modified xsi:type="dcterms:W3CDTF">2008-05-23T22:01:24Z</dcterms:modified>
  <cp:revision>6</cp:revision>
  <dc:subject/>
  <dc:title>Folie 1</dc:title>
</cp:coreProperties>
</file>